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6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917800" cy="493560"/>
          </a:xfrm>
          <a:prstGeom prst="rect">
            <a:avLst/>
          </a:prstGeom>
          <a:noFill/>
          <a:ln w="0">
            <a:noFill/>
          </a:ln>
        </p:spPr>
        <p:txBody>
          <a:bodyPr lIns="90720" rIns="90720" tIns="45360" bIns="453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14560" y="-360"/>
            <a:ext cx="2917800" cy="493560"/>
          </a:xfrm>
          <a:prstGeom prst="rect">
            <a:avLst/>
          </a:prstGeom>
          <a:noFill/>
          <a:ln w="0">
            <a:noFill/>
          </a:ln>
        </p:spPr>
        <p:txBody>
          <a:bodyPr lIns="90720" rIns="90720" tIns="45360" bIns="4536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03240" y="740880"/>
            <a:ext cx="4929120" cy="369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720" rIns="90720" tIns="45360" bIns="453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3200" y="4687560"/>
            <a:ext cx="5387760" cy="4438440"/>
          </a:xfrm>
          <a:prstGeom prst="rect">
            <a:avLst/>
          </a:prstGeom>
          <a:noFill/>
          <a:ln w="0">
            <a:noFill/>
          </a:ln>
        </p:spPr>
        <p:txBody>
          <a:bodyPr lIns="90720" rIns="90720" tIns="45360" bIns="4536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372240"/>
            <a:ext cx="2917800" cy="493560"/>
          </a:xfrm>
          <a:prstGeom prst="rect">
            <a:avLst/>
          </a:prstGeom>
          <a:noFill/>
          <a:ln w="0">
            <a:noFill/>
          </a:ln>
        </p:spPr>
        <p:txBody>
          <a:bodyPr lIns="90720" rIns="90720" tIns="45360" bIns="4536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14560" y="9372240"/>
            <a:ext cx="2917800" cy="493560"/>
          </a:xfrm>
          <a:prstGeom prst="rect">
            <a:avLst/>
          </a:prstGeom>
          <a:noFill/>
          <a:ln w="0">
            <a:noFill/>
          </a:ln>
        </p:spPr>
        <p:txBody>
          <a:bodyPr lIns="90720" rIns="90720" tIns="45360" bIns="4536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BA97F5-992B-4D11-9A30-3D0617CA5718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903240" y="741240"/>
            <a:ext cx="4929120" cy="369900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673200" y="4687560"/>
            <a:ext cx="5387760" cy="4438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スライド番号プレースホルダ 3"/>
          <p:cNvSpPr/>
          <p:nvPr/>
        </p:nvSpPr>
        <p:spPr>
          <a:xfrm>
            <a:off x="3814920" y="9372600"/>
            <a:ext cx="291780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720" rIns="90720" tIns="45360" bIns="4536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415740-FBCF-47E4-9989-9474EAE4E008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691B5-CB9E-41DD-8615-EB729127D3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24B57A-CAC0-4502-8A2B-869A6138F3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C79E51-4428-4C5C-9B6F-710545092D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1E65A1-5E28-41D4-90D0-BDEA10C9EA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017B8-1AF0-4AD5-A89C-7ED25FB57C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917AD0-AFF1-4B8F-BC52-BF42FAF899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111E06-2A01-4F6A-A7AA-F4263A0FBF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B2EBED-404F-4D32-A81C-EDE8EBB7E5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13FDB-159E-47DA-8FD1-46457F1969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F2EFC-221F-4158-8E3C-0291462A71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88B59B-72E0-419D-90B8-79B5C15AC4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86F69-886C-4432-A4ED-E147431757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AC7147-D944-48C9-9AB8-A1C8544A591B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7"/>
          <p:cNvSpPr/>
          <p:nvPr/>
        </p:nvSpPr>
        <p:spPr>
          <a:xfrm>
            <a:off x="6134400" y="4916520"/>
            <a:ext cx="86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all ra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8"/>
          <p:cNvSpPr/>
          <p:nvPr/>
        </p:nvSpPr>
        <p:spPr>
          <a:xfrm>
            <a:off x="1446840" y="4905360"/>
            <a:ext cx="133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tandard dev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12"/>
          <p:cNvSpPr/>
          <p:nvPr/>
        </p:nvSpPr>
        <p:spPr>
          <a:xfrm>
            <a:off x="1449360" y="5429160"/>
            <a:ext cx="101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 1S-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13"/>
          <p:cNvSpPr/>
          <p:nvPr/>
        </p:nvSpPr>
        <p:spPr>
          <a:xfrm>
            <a:off x="6015240" y="5429160"/>
            <a:ext cx="102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 1S-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14"/>
          <p:cNvSpPr/>
          <p:nvPr/>
        </p:nvSpPr>
        <p:spPr>
          <a:xfrm>
            <a:off x="7894080" y="4452840"/>
            <a:ext cx="38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(%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16"/>
          <p:cNvSpPr/>
          <p:nvPr/>
        </p:nvSpPr>
        <p:spPr>
          <a:xfrm rot="16200000">
            <a:off x="-895680" y="2941920"/>
            <a:ext cx="2527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Num. of CNVs per individu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15"/>
          <p:cNvSpPr/>
          <p:nvPr/>
        </p:nvSpPr>
        <p:spPr>
          <a:xfrm rot="16200000">
            <a:off x="3510000" y="2776680"/>
            <a:ext cx="257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Num. of CNVs  per individu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グラフ 10" descr=""/>
          <p:cNvPicPr/>
          <p:nvPr/>
        </p:nvPicPr>
        <p:blipFill>
          <a:blip r:embed="rId1"/>
          <a:stretch/>
        </p:blipFill>
        <p:spPr>
          <a:xfrm>
            <a:off x="4705200" y="1279440"/>
            <a:ext cx="4445280" cy="3530520"/>
          </a:xfrm>
          <a:prstGeom prst="rect">
            <a:avLst/>
          </a:prstGeom>
          <a:ln w="0">
            <a:noFill/>
          </a:ln>
        </p:spPr>
      </p:pic>
      <p:pic>
        <p:nvPicPr>
          <p:cNvPr id="56" name="グラフ 11" descr=""/>
          <p:cNvPicPr/>
          <p:nvPr/>
        </p:nvPicPr>
        <p:blipFill>
          <a:blip r:embed="rId2"/>
          <a:stretch/>
        </p:blipFill>
        <p:spPr>
          <a:xfrm>
            <a:off x="208080" y="1279440"/>
            <a:ext cx="4510080" cy="3548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テキスト ボックス 7"/>
          <p:cNvSpPr/>
          <p:nvPr/>
        </p:nvSpPr>
        <p:spPr>
          <a:xfrm>
            <a:off x="5991480" y="4786200"/>
            <a:ext cx="86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all ra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8"/>
          <p:cNvSpPr/>
          <p:nvPr/>
        </p:nvSpPr>
        <p:spPr>
          <a:xfrm>
            <a:off x="1479960" y="4786200"/>
            <a:ext cx="133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tandard dev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9"/>
          <p:cNvSpPr/>
          <p:nvPr/>
        </p:nvSpPr>
        <p:spPr>
          <a:xfrm>
            <a:off x="1663560" y="5429160"/>
            <a:ext cx="101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 2S-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11"/>
          <p:cNvSpPr/>
          <p:nvPr/>
        </p:nvSpPr>
        <p:spPr>
          <a:xfrm>
            <a:off x="5815080" y="5429160"/>
            <a:ext cx="102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 2S-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13"/>
          <p:cNvSpPr/>
          <p:nvPr/>
        </p:nvSpPr>
        <p:spPr>
          <a:xfrm>
            <a:off x="7679520" y="4357800"/>
            <a:ext cx="38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(%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15"/>
          <p:cNvSpPr/>
          <p:nvPr/>
        </p:nvSpPr>
        <p:spPr>
          <a:xfrm rot="16200000">
            <a:off x="3722400" y="2860560"/>
            <a:ext cx="25052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Num. of CNVs per individu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16"/>
          <p:cNvSpPr/>
          <p:nvPr/>
        </p:nvSpPr>
        <p:spPr>
          <a:xfrm rot="16200000">
            <a:off x="-974160" y="2932200"/>
            <a:ext cx="257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Num. of CNVs  per individu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グラフ 10" descr=""/>
          <p:cNvPicPr/>
          <p:nvPr/>
        </p:nvPicPr>
        <p:blipFill>
          <a:blip r:embed="rId1"/>
          <a:stretch/>
        </p:blipFill>
        <p:spPr>
          <a:xfrm>
            <a:off x="4780080" y="1206360"/>
            <a:ext cx="4230720" cy="3505320"/>
          </a:xfrm>
          <a:prstGeom prst="rect">
            <a:avLst/>
          </a:prstGeom>
          <a:ln w="0">
            <a:noFill/>
          </a:ln>
        </p:spPr>
      </p:pic>
      <p:pic>
        <p:nvPicPr>
          <p:cNvPr id="65" name="グラフ 12" descr=""/>
          <p:cNvPicPr/>
          <p:nvPr/>
        </p:nvPicPr>
        <p:blipFill>
          <a:blip r:embed="rId2"/>
          <a:stretch/>
        </p:blipFill>
        <p:spPr>
          <a:xfrm>
            <a:off x="353880" y="1206360"/>
            <a:ext cx="4510080" cy="3517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23T02:07:03Z</dcterms:created>
  <dc:creator>akoike</dc:creator>
  <dc:description/>
  <dc:language>en-US</dc:language>
  <cp:lastModifiedBy>akoike</cp:lastModifiedBy>
  <dcterms:modified xsi:type="dcterms:W3CDTF">2011-02-10T09:46:38Z</dcterms:modified>
  <cp:revision>96</cp:revision>
  <dc:subject/>
  <dc:title>スライド 1</dc:title>
</cp:coreProperties>
</file>